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hen, Grace - ARS" initials="CG-A" lastIdx="1" clrIdx="0">
    <p:extLst>
      <p:ext uri="{19B8F6BF-5375-455C-9EA6-DF929625EA0E}">
        <p15:presenceInfo xmlns:p15="http://schemas.microsoft.com/office/powerpoint/2012/main" userId="S::grace.chen@usda.gov::fc8675f0-b7ac-4f5b-8942-ea746a6b971e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0" d="100"/>
          <a:sy n="80" d="100"/>
        </p:scale>
        <p:origin x="499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9E0B9-FC9F-4057-8ADF-7DFAE79C803F}" type="datetimeFigureOut">
              <a:rPr lang="ko-KR" altLang="en-US" smtClean="0"/>
              <a:t>2021-01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3432-1A1A-482D-8A72-BCD1E19FDB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975105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9E0B9-FC9F-4057-8ADF-7DFAE79C803F}" type="datetimeFigureOut">
              <a:rPr lang="ko-KR" altLang="en-US" smtClean="0"/>
              <a:t>2021-01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3432-1A1A-482D-8A72-BCD1E19FDB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481651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9E0B9-FC9F-4057-8ADF-7DFAE79C803F}" type="datetimeFigureOut">
              <a:rPr lang="ko-KR" altLang="en-US" smtClean="0"/>
              <a:t>2021-01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3432-1A1A-482D-8A72-BCD1E19FDB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425286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9E0B9-FC9F-4057-8ADF-7DFAE79C803F}" type="datetimeFigureOut">
              <a:rPr lang="ko-KR" altLang="en-US" smtClean="0"/>
              <a:t>2021-01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3432-1A1A-482D-8A72-BCD1E19FDB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254522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9E0B9-FC9F-4057-8ADF-7DFAE79C803F}" type="datetimeFigureOut">
              <a:rPr lang="ko-KR" altLang="en-US" smtClean="0"/>
              <a:t>2021-01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3432-1A1A-482D-8A72-BCD1E19FDB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16618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9E0B9-FC9F-4057-8ADF-7DFAE79C803F}" type="datetimeFigureOut">
              <a:rPr lang="ko-KR" altLang="en-US" smtClean="0"/>
              <a:t>2021-01-0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3432-1A1A-482D-8A72-BCD1E19FDB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682222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9E0B9-FC9F-4057-8ADF-7DFAE79C803F}" type="datetimeFigureOut">
              <a:rPr lang="ko-KR" altLang="en-US" smtClean="0"/>
              <a:t>2021-01-0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3432-1A1A-482D-8A72-BCD1E19FDB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982248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9E0B9-FC9F-4057-8ADF-7DFAE79C803F}" type="datetimeFigureOut">
              <a:rPr lang="ko-KR" altLang="en-US" smtClean="0"/>
              <a:t>2021-01-0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3432-1A1A-482D-8A72-BCD1E19FDB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155243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9E0B9-FC9F-4057-8ADF-7DFAE79C803F}" type="datetimeFigureOut">
              <a:rPr lang="ko-KR" altLang="en-US" smtClean="0"/>
              <a:t>2021-01-0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3432-1A1A-482D-8A72-BCD1E19FDB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249277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9E0B9-FC9F-4057-8ADF-7DFAE79C803F}" type="datetimeFigureOut">
              <a:rPr lang="ko-KR" altLang="en-US" smtClean="0"/>
              <a:t>2021-01-0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3432-1A1A-482D-8A72-BCD1E19FDB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084606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9E0B9-FC9F-4057-8ADF-7DFAE79C803F}" type="datetimeFigureOut">
              <a:rPr lang="ko-KR" altLang="en-US" smtClean="0"/>
              <a:t>2021-01-0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43432-1A1A-482D-8A72-BCD1E19FDB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116157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F9E0B9-FC9F-4057-8ADF-7DFAE79C803F}" type="datetimeFigureOut">
              <a:rPr lang="ko-KR" altLang="en-US" smtClean="0"/>
              <a:t>2021-01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643432-1A1A-482D-8A72-BCD1E19FDB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9008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개체 9">
            <a:extLst>
              <a:ext uri="{FF2B5EF4-FFF2-40B4-BE49-F238E27FC236}">
                <a16:creationId xmlns:a16="http://schemas.microsoft.com/office/drawing/2014/main" id="{BD9DE1D0-52A6-4E83-BE07-A69662FBDE1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75899749"/>
              </p:ext>
            </p:extLst>
          </p:nvPr>
        </p:nvGraphicFramePr>
        <p:xfrm>
          <a:off x="3484563" y="3433763"/>
          <a:ext cx="2343150" cy="30368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8" name="Prism 7" r:id="rId3" imgW="2343403" imgH="3037179" progId="Prism7.Document">
                  <p:embed/>
                </p:oleObj>
              </mc:Choice>
              <mc:Fallback>
                <p:oleObj name="Prism 7" r:id="rId3" imgW="2343403" imgH="3037179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484563" y="3433763"/>
                        <a:ext cx="2343150" cy="30368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개체 8">
            <a:extLst>
              <a:ext uri="{FF2B5EF4-FFF2-40B4-BE49-F238E27FC236}">
                <a16:creationId xmlns:a16="http://schemas.microsoft.com/office/drawing/2014/main" id="{1D91554F-7287-4CC9-B543-2C198EE3870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00809065"/>
              </p:ext>
            </p:extLst>
          </p:nvPr>
        </p:nvGraphicFramePr>
        <p:xfrm>
          <a:off x="1030288" y="3433763"/>
          <a:ext cx="2343150" cy="30368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9" name="Prism 7" r:id="rId5" imgW="2343403" imgH="3037179" progId="Prism7.Document">
                  <p:embed/>
                </p:oleObj>
              </mc:Choice>
              <mc:Fallback>
                <p:oleObj name="Prism 7" r:id="rId5" imgW="2343403" imgH="3037179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030288" y="3433763"/>
                        <a:ext cx="2343150" cy="30368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DDF999E8-139B-46FD-82B2-BDCC011E9F03}"/>
              </a:ext>
            </a:extLst>
          </p:cNvPr>
          <p:cNvSpPr txBox="1"/>
          <p:nvPr/>
        </p:nvSpPr>
        <p:spPr>
          <a:xfrm>
            <a:off x="1000447" y="7391433"/>
            <a:ext cx="50524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3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ranscript level </a:t>
            </a:r>
            <a:r>
              <a:rPr lang="en-US" sz="1200" i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PLD</a:t>
            </a:r>
            <a:r>
              <a:rPr lang="el-G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ζ</a:t>
            </a:r>
            <a:r>
              <a:rPr lang="en-US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l-G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200" i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PLD</a:t>
            </a:r>
            <a:r>
              <a:rPr lang="el-G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ζ</a:t>
            </a:r>
            <a:r>
              <a:rPr lang="en-US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ntigs in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.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lindhemeri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ranscriptomes. (A)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PlPLD</a:t>
            </a:r>
            <a:r>
              <a:rPr lang="el-GR" sz="1200" i="1" dirty="0">
                <a:latin typeface="Arial" panose="020B0604020202020204" pitchFamily="34" charset="0"/>
                <a:cs typeface="Arial" panose="020B0604020202020204" pitchFamily="34" charset="0"/>
              </a:rPr>
              <a:t>ζ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l-GR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(B)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PlPLD</a:t>
            </a:r>
            <a:r>
              <a:rPr lang="el-GR" sz="1200" i="1" dirty="0">
                <a:latin typeface="Arial" panose="020B0604020202020204" pitchFamily="34" charset="0"/>
                <a:cs typeface="Arial" panose="020B0604020202020204" pitchFamily="34" charset="0"/>
              </a:rPr>
              <a:t>ζ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DAP, days after pollination; F, flower bud; L, leaf.</a:t>
            </a:r>
            <a:endParaRPr lang="en-US" sz="1200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0514FA0-286A-416C-A5F7-F87BE1494A56}"/>
              </a:ext>
            </a:extLst>
          </p:cNvPr>
          <p:cNvSpPr txBox="1"/>
          <p:nvPr/>
        </p:nvSpPr>
        <p:spPr>
          <a:xfrm>
            <a:off x="1063487" y="333954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58A2595-9C11-413C-9538-4A6CC24B678C}"/>
              </a:ext>
            </a:extLst>
          </p:cNvPr>
          <p:cNvSpPr txBox="1"/>
          <p:nvPr/>
        </p:nvSpPr>
        <p:spPr>
          <a:xfrm>
            <a:off x="3551583" y="327328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6624372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</TotalTime>
  <Words>50</Words>
  <Application>Microsoft Office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테마</vt:lpstr>
      <vt:lpstr>Prism 7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원녕</dc:creator>
  <cp:lastModifiedBy>Chen, Grace - ARS</cp:lastModifiedBy>
  <cp:revision>9</cp:revision>
  <dcterms:created xsi:type="dcterms:W3CDTF">2020-12-11T05:18:28Z</dcterms:created>
  <dcterms:modified xsi:type="dcterms:W3CDTF">2021-01-05T22:49:17Z</dcterms:modified>
</cp:coreProperties>
</file>